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2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2" autoAdjust="0"/>
    <p:restoredTop sz="94660"/>
  </p:normalViewPr>
  <p:slideViewPr>
    <p:cSldViewPr snapToGrid="0">
      <p:cViewPr varScale="1">
        <p:scale>
          <a:sx n="90" d="100"/>
          <a:sy n="90" d="100"/>
        </p:scale>
        <p:origin x="47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6E4AD1B-703E-40CD-A2CC-882ACC2A3EA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3F26B5AB-DA55-43B5-AA06-EC5F3EA7B4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374D402-2F8E-4791-89F3-8E781E93EC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6F19-D071-4737-A18D-1FB93B16B43D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C773294-0638-4761-B77C-513C3EFD18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6747123-72D8-4115-9BEB-1C2969A8B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F53B1-FB03-4CAE-BAE2-B5EED05501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1203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9DF3CC9-5DCB-4D31-AC22-948E72AE55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20EC7D83-DBF4-4E65-ACAB-E0ABB8146F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48AE994-9805-4639-A017-667258109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6F19-D071-4737-A18D-1FB93B16B43D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42C3848-B912-47C6-8877-104124858A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1D429E0-E898-4280-8E33-A6E13BEB1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F53B1-FB03-4CAE-BAE2-B5EED05501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47242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8FAD903-A81E-47B5-9298-902709C781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AEDF880-97F7-47C6-9705-4BCD854894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327EF38-7499-4A77-9F3E-A51A698DC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6F19-D071-4737-A18D-1FB93B16B43D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FE1CF1E-1F03-4F18-AF0C-91F8E5D600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1E45C72-C4FC-4975-A4A5-EE0AF0D88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F53B1-FB03-4CAE-BAE2-B5EED05501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12264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6C357A9-15FE-46B2-BD67-86F1C04341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C5B3693-8B8A-4BE3-9DFB-2A5C588CA8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4868513-2F2E-43E9-8532-3D513E64D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6F19-D071-4737-A18D-1FB93B16B43D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12B2D67-69A8-4704-BDAD-032D0E1E35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82C40C7-2006-4D0F-90CD-A43E7EF99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F53B1-FB03-4CAE-BAE2-B5EED05501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27767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299DC07-05E3-4A24-8FD4-574FC9AFA4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313A07B-D089-4F4D-9054-9A0C45D294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1D1DBA9-CCF3-446D-83FC-6F8F2E0D71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6F19-D071-4737-A18D-1FB93B16B43D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A225AC23-78BE-4355-AAEB-3F9B98FCD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3DD0FC5-2403-478F-8BCB-4E21DF791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F53B1-FB03-4CAE-BAE2-B5EED05501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1954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A66CD05-B17B-48DD-B9F2-BBFE63D016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94B7E14-7902-49F6-8F4F-7B5ED8672F1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80506801-8C29-48CD-B5FC-53989C928D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CDF486E-B36F-47E4-873E-55583E27B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6F19-D071-4737-A18D-1FB93B16B43D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A69A805-88C8-412A-8CA4-D2564523D1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F79DE20-6817-4AD8-887F-BEF9866C7E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F53B1-FB03-4CAE-BAE2-B5EED05501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1286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6C7342C-53F1-48CB-B2BD-4BDB0A6967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9BFE62EC-FCAC-45F8-9C3A-7327F00045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B877F95-E745-42AD-A06F-3BB1F727F1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DBB7F899-1F6B-482E-87AF-49E81C5D88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DE1EF5F3-B8D9-4DCB-A67B-86D8D43711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16457BF2-00F0-4D7F-B292-F7726EA3E0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6F19-D071-4737-A18D-1FB93B16B43D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CA08A07C-14BF-43B2-8F12-7D8907695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18F475B1-954E-494D-A2D8-6A219767E9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F53B1-FB03-4CAE-BAE2-B5EED05501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06226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BB1D342-F72C-4870-A285-A087BE66D2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26C06CC8-0C28-4C62-B984-4471CE671A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6F19-D071-4737-A18D-1FB93B16B43D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ECA3B8BA-3B0C-43F8-94C8-80DCD41CCC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2ED4BDB5-7BE1-460F-BC37-B6F663EFFD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F53B1-FB03-4CAE-BAE2-B5EED05501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483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7F8287F9-8E39-492D-829D-8656CE2204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6F19-D071-4737-A18D-1FB93B16B43D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9D251F3-55B9-48A8-B018-E2B7168D1B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439CF23A-5A7B-4016-8401-10C67E6DD5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F53B1-FB03-4CAE-BAE2-B5EED05501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7563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9B38CD5-1E36-40CA-AFE9-B250516B16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6AEEDE5-C999-47F7-B637-4378D72B4D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580FDB7-D333-4A21-BDFB-CC395246AB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9C32AA76-94CD-4DAE-B671-0DF761A8E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6F19-D071-4737-A18D-1FB93B16B43D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666B90B-5B4B-42AA-BA4E-8D753610F3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51A3468-4FB6-4111-B708-DB9334F195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F53B1-FB03-4CAE-BAE2-B5EED05501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64938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6C0105C-8DC6-4F78-87CC-56BD550779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B14C46F8-0834-4673-A284-C2620F59E6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DE1AE72-CB7D-4FC2-AFDD-C77F749318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CC0462F-460A-4EF2-A3BC-E75C6D38C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746F19-D071-4737-A18D-1FB93B16B43D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DD4E390-D8F4-4D29-8642-3DDDAC4D6B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707E56A-2B55-404A-89AE-3E265B67D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EF53B1-FB03-4CAE-BAE2-B5EED05501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9899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6EF4995D-C1B6-4CE3-A6E1-D01E7F5137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AEC0DCD-0557-44AD-AAD4-000ACA989F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B3D71EC-2061-4DA4-BE47-1A48ECF118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746F19-D071-4737-A18D-1FB93B16B43D}" type="datetimeFigureOut">
              <a:rPr lang="fr-FR" smtClean="0"/>
              <a:t>18/09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3B3D7FA-4110-4848-B311-EF845B7224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CCD592D-CDF7-4561-B4DB-50A8B41303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EF53B1-FB03-4CAE-BAE2-B5EED055014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32966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>
            <a:extLst>
              <a:ext uri="{FF2B5EF4-FFF2-40B4-BE49-F238E27FC236}">
                <a16:creationId xmlns:a16="http://schemas.microsoft.com/office/drawing/2014/main" id="{22D318E2-4830-4941-AFCB-63FD324FAF64}"/>
              </a:ext>
            </a:extLst>
          </p:cNvPr>
          <p:cNvGrpSpPr/>
          <p:nvPr/>
        </p:nvGrpSpPr>
        <p:grpSpPr>
          <a:xfrm>
            <a:off x="175702" y="247680"/>
            <a:ext cx="11783845" cy="6037150"/>
            <a:chOff x="70602" y="247680"/>
            <a:chExt cx="11783845" cy="6037150"/>
          </a:xfrm>
        </p:grpSpPr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CA026455-A9BB-42DE-AD65-8D304DD61675}"/>
                </a:ext>
              </a:extLst>
            </p:cNvPr>
            <p:cNvSpPr txBox="1"/>
            <p:nvPr/>
          </p:nvSpPr>
          <p:spPr>
            <a:xfrm>
              <a:off x="303658" y="247680"/>
              <a:ext cx="20123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Un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endParaRPr lang="fr-FR" sz="1400" b="1" dirty="0"/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3E095E98-FB10-4632-ABAC-8D5D7E24BB14}"/>
                </a:ext>
              </a:extLst>
            </p:cNvPr>
            <p:cNvSpPr txBox="1"/>
            <p:nvPr/>
          </p:nvSpPr>
          <p:spPr>
            <a:xfrm>
              <a:off x="9360942" y="2607813"/>
              <a:ext cx="21583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labeled</a:t>
              </a:r>
              <a:r>
                <a:rPr lang="fr-FR" sz="1200" dirty="0"/>
                <a:t> T lymphocytes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98F442FB-E16F-48C2-8300-436C8FCB20B1}"/>
                </a:ext>
              </a:extLst>
            </p:cNvPr>
            <p:cNvSpPr txBox="1"/>
            <p:nvPr/>
          </p:nvSpPr>
          <p:spPr>
            <a:xfrm>
              <a:off x="131646" y="2279146"/>
              <a:ext cx="25378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r>
                <a:rPr lang="fr-FR" sz="1400" b="1" dirty="0"/>
                <a:t> by the </a:t>
              </a:r>
              <a:r>
                <a:rPr lang="el-GR" sz="1400" b="1" dirty="0"/>
                <a:t>3Δ</a:t>
              </a:r>
              <a:r>
                <a:rPr lang="fr-FR" sz="1400" b="1" dirty="0"/>
                <a:t>  </a:t>
              </a:r>
              <a:r>
                <a:rPr lang="fr-FR" sz="1400" b="1" dirty="0" err="1"/>
                <a:t>strain</a:t>
              </a:r>
              <a:endParaRPr lang="fr-FR" sz="1400" b="1" dirty="0"/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B679AC25-A109-4D68-AE69-D05E667E6BF3}"/>
                </a:ext>
              </a:extLst>
            </p:cNvPr>
            <p:cNvSpPr txBox="1"/>
            <p:nvPr/>
          </p:nvSpPr>
          <p:spPr>
            <a:xfrm>
              <a:off x="9370951" y="3797785"/>
              <a:ext cx="24834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unlabeled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01D3C4F2-309A-4C18-BF71-65F2682EA3EF}"/>
                </a:ext>
              </a:extLst>
            </p:cNvPr>
            <p:cNvSpPr txBox="1"/>
            <p:nvPr/>
          </p:nvSpPr>
          <p:spPr>
            <a:xfrm>
              <a:off x="70602" y="4630066"/>
              <a:ext cx="279384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r>
                <a:rPr lang="fr-FR" sz="1400" b="1" dirty="0"/>
                <a:t> by the </a:t>
              </a:r>
              <a:r>
                <a:rPr lang="el-GR" sz="1400" b="1" dirty="0"/>
                <a:t>Δ</a:t>
              </a:r>
              <a:r>
                <a:rPr lang="fr-FR" sz="1400" b="1" i="1" dirty="0" err="1"/>
                <a:t>invA</a:t>
              </a:r>
              <a:r>
                <a:rPr lang="fr-FR" sz="1400" b="1" dirty="0"/>
                <a:t> </a:t>
              </a:r>
              <a:r>
                <a:rPr lang="fr-FR" sz="1400" b="1" dirty="0" err="1"/>
                <a:t>strain</a:t>
              </a:r>
              <a:endParaRPr lang="fr-FR" sz="1400" b="1" dirty="0"/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86EFF6E0-B7BE-46C0-9302-C50A21ADD3AF}"/>
                </a:ext>
              </a:extLst>
            </p:cNvPr>
            <p:cNvSpPr txBox="1"/>
            <p:nvPr/>
          </p:nvSpPr>
          <p:spPr>
            <a:xfrm>
              <a:off x="9370951" y="5994575"/>
              <a:ext cx="24834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unlabeled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9238B342-6126-4A1A-9010-75B7981EF156}"/>
                </a:ext>
              </a:extLst>
            </p:cNvPr>
            <p:cNvSpPr txBox="1"/>
            <p:nvPr/>
          </p:nvSpPr>
          <p:spPr>
            <a:xfrm>
              <a:off x="1289017" y="877775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97A99491-2D1B-497C-82EA-96D163338B05}"/>
                </a:ext>
              </a:extLst>
            </p:cNvPr>
            <p:cNvSpPr txBox="1"/>
            <p:nvPr/>
          </p:nvSpPr>
          <p:spPr>
            <a:xfrm>
              <a:off x="1309845" y="3054398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BFA6729E-1564-4DE0-8970-E67A88961C76}"/>
                </a:ext>
              </a:extLst>
            </p:cNvPr>
            <p:cNvSpPr txBox="1"/>
            <p:nvPr/>
          </p:nvSpPr>
          <p:spPr>
            <a:xfrm>
              <a:off x="1253206" y="5301844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BD24A082-87FB-40AB-9AEA-F3A7CE6818C7}"/>
                </a:ext>
              </a:extLst>
            </p:cNvPr>
            <p:cNvSpPr txBox="1"/>
            <p:nvPr/>
          </p:nvSpPr>
          <p:spPr>
            <a:xfrm>
              <a:off x="5711985" y="481540"/>
              <a:ext cx="16526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Labeled</a:t>
              </a:r>
              <a:r>
                <a:rPr lang="fr-FR" sz="1200" dirty="0"/>
                <a:t> T lymphocytes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4A201F4E-6FCB-43A9-AE3F-8A1950B5E89A}"/>
                </a:ext>
              </a:extLst>
            </p:cNvPr>
            <p:cNvSpPr txBox="1"/>
            <p:nvPr/>
          </p:nvSpPr>
          <p:spPr>
            <a:xfrm>
              <a:off x="5948814" y="6007831"/>
              <a:ext cx="13180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Unlabeled</a:t>
              </a:r>
              <a:r>
                <a:rPr lang="fr-FR" sz="1200" dirty="0"/>
                <a:t> 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0320534D-BA65-4729-A678-FC6B0FF2FCF9}"/>
                </a:ext>
              </a:extLst>
            </p:cNvPr>
            <p:cNvSpPr txBox="1"/>
            <p:nvPr/>
          </p:nvSpPr>
          <p:spPr>
            <a:xfrm>
              <a:off x="5955455" y="3822197"/>
              <a:ext cx="13180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Unlabeled</a:t>
              </a:r>
              <a:r>
                <a:rPr lang="fr-FR" sz="1200" dirty="0"/>
                <a:t> 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</p:grpSp>
      <p:sp>
        <p:nvSpPr>
          <p:cNvPr id="41" name="ZoneTexte 40">
            <a:extLst>
              <a:ext uri="{FF2B5EF4-FFF2-40B4-BE49-F238E27FC236}">
                <a16:creationId xmlns:a16="http://schemas.microsoft.com/office/drawing/2014/main" id="{767BB29B-24FB-4CE7-8123-E1A816F4AC24}"/>
              </a:ext>
            </a:extLst>
          </p:cNvPr>
          <p:cNvSpPr txBox="1"/>
          <p:nvPr/>
        </p:nvSpPr>
        <p:spPr>
          <a:xfrm>
            <a:off x="10205545" y="291263"/>
            <a:ext cx="1619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S4 </a:t>
            </a:r>
            <a:r>
              <a:rPr lang="fr-FR" b="1"/>
              <a:t>Fig</a:t>
            </a:r>
            <a:endParaRPr lang="fr-FR" b="1" dirty="0"/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4A201F29-7FB3-420C-BD4F-4C3EEAA8A5EE}"/>
              </a:ext>
            </a:extLst>
          </p:cNvPr>
          <p:cNvSpPr txBox="1"/>
          <p:nvPr/>
        </p:nvSpPr>
        <p:spPr>
          <a:xfrm>
            <a:off x="5719360" y="2653750"/>
            <a:ext cx="1652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/>
              <a:t>Labeled</a:t>
            </a:r>
            <a:r>
              <a:rPr lang="fr-FR" sz="1200" dirty="0"/>
              <a:t> T lymphocytes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18A0A4DB-1F53-4750-BB66-5BE0DD18FF85}"/>
              </a:ext>
            </a:extLst>
          </p:cNvPr>
          <p:cNvSpPr txBox="1"/>
          <p:nvPr/>
        </p:nvSpPr>
        <p:spPr>
          <a:xfrm>
            <a:off x="5630240" y="4887668"/>
            <a:ext cx="1652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/>
              <a:t>Labeled</a:t>
            </a:r>
            <a:r>
              <a:rPr lang="fr-FR" sz="1200" dirty="0"/>
              <a:t> T lymphocytes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6A8C3BE8-0DB0-4006-A348-EEB4244F46D7}"/>
              </a:ext>
            </a:extLst>
          </p:cNvPr>
          <p:cNvSpPr txBox="1"/>
          <p:nvPr/>
        </p:nvSpPr>
        <p:spPr>
          <a:xfrm>
            <a:off x="9466043" y="4869509"/>
            <a:ext cx="21583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/>
              <a:t>Infected</a:t>
            </a:r>
            <a:r>
              <a:rPr lang="fr-FR" sz="1200" dirty="0"/>
              <a:t> </a:t>
            </a:r>
            <a:r>
              <a:rPr lang="fr-FR" sz="1200" dirty="0" err="1"/>
              <a:t>labeled</a:t>
            </a:r>
            <a:r>
              <a:rPr lang="fr-FR" sz="1200" dirty="0"/>
              <a:t> T lymphocytes</a:t>
            </a:r>
          </a:p>
        </p:txBody>
      </p:sp>
      <p:pic>
        <p:nvPicPr>
          <p:cNvPr id="28" name="Picture 4" descr="C:\Users\trs-confocal\AppData\Local\Temp\tmp04195706296534433650.png">
            <a:extLst>
              <a:ext uri="{FF2B5EF4-FFF2-40B4-BE49-F238E27FC236}">
                <a16:creationId xmlns:a16="http://schemas.microsoft.com/office/drawing/2014/main" id="{43AA8114-D602-41B3-AE77-A60A7774DB3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9613" y="159176"/>
            <a:ext cx="2024608" cy="21199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7" descr="C:\Users\trs-confocal\AppData\Local\Temp\tmp08364600902379963111.png">
            <a:extLst>
              <a:ext uri="{FF2B5EF4-FFF2-40B4-BE49-F238E27FC236}">
                <a16:creationId xmlns:a16="http://schemas.microsoft.com/office/drawing/2014/main" id="{F835F277-D080-4F54-A7B1-98613D0919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6863" y="2417016"/>
            <a:ext cx="1997357" cy="20914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Picture 10" descr="C:\Users\trs-confocal\AppData\Local\Temp\tmp07783765127689608703.png">
            <a:extLst>
              <a:ext uri="{FF2B5EF4-FFF2-40B4-BE49-F238E27FC236}">
                <a16:creationId xmlns:a16="http://schemas.microsoft.com/office/drawing/2014/main" id="{DC91087F-39C2-4687-B368-32B4BE4471F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6863" y="4612373"/>
            <a:ext cx="2024608" cy="21199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4" name="Picture 4" descr="C:\Users\trs-confocal\AppData\Local\Temp\tmp18878511346206738612.png">
            <a:extLst>
              <a:ext uri="{FF2B5EF4-FFF2-40B4-BE49-F238E27FC236}">
                <a16:creationId xmlns:a16="http://schemas.microsoft.com/office/drawing/2014/main" id="{40DC5690-3F0C-4435-A80C-42DE60EAB8E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69709" y="159176"/>
            <a:ext cx="2024608" cy="21199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5" name="Picture 8" descr="C:\Users\trs-confocal\AppData\Local\Temp\tmp15273624836067779792.png">
            <a:extLst>
              <a:ext uri="{FF2B5EF4-FFF2-40B4-BE49-F238E27FC236}">
                <a16:creationId xmlns:a16="http://schemas.microsoft.com/office/drawing/2014/main" id="{E9F5EE02-6831-4932-B3E4-34C4A04ACEE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96960" y="2417016"/>
            <a:ext cx="1997357" cy="20914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6" name="Picture 12" descr="C:\Users\trs-confocal\AppData\Local\Temp\tmp17170613321168660624.png">
            <a:extLst>
              <a:ext uri="{FF2B5EF4-FFF2-40B4-BE49-F238E27FC236}">
                <a16:creationId xmlns:a16="http://schemas.microsoft.com/office/drawing/2014/main" id="{F265F132-0C37-4575-8F44-C34DACF17BE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0921" y="4612373"/>
            <a:ext cx="1965130" cy="20576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1197695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50</Words>
  <Application>Microsoft Office PowerPoint</Application>
  <PresentationFormat>Grand écran</PresentationFormat>
  <Paragraphs>1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ylvie Roche</dc:creator>
  <cp:lastModifiedBy>Sylvie Roche</cp:lastModifiedBy>
  <cp:revision>3</cp:revision>
  <dcterms:created xsi:type="dcterms:W3CDTF">2020-06-04T06:35:46Z</dcterms:created>
  <dcterms:modified xsi:type="dcterms:W3CDTF">2020-09-18T09:07:26Z</dcterms:modified>
</cp:coreProperties>
</file>